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125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6" d="100"/>
          <a:sy n="96" d="100"/>
        </p:scale>
        <p:origin x="90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D0A63C-A5AD-9900-C771-D3D9C64B7E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47C4FDB-B50B-E90D-BE6A-102ABA8C6A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4E22FA-F894-D33A-1574-5E8925F8EB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9F12EE-A301-9A3D-DF8D-67694C900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AB7A31-0BE1-E411-2024-F03EE36EA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715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8FF323-D30E-FCA2-72CA-5C958FF800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DFA443-28F7-0F47-5E96-E77DC05B2D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108CF-7302-C87C-7C42-E82574F813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6A79BD-9584-07A2-EC77-57F7BF718E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81BA6C-A8DF-F0A9-5DFF-AA406FB23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540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8486F3D-B9A6-E846-7F7C-EDBD7C3261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0D80ED-90E4-B8AC-E5CD-F1EFE42224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A2AFCB-1679-4B33-22AF-9B10F4742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51DBA9-1D9F-B45F-9240-8FEB378AC3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E4AD51-6D6A-A4FE-138D-0631D0B67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966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CD8C52-6224-57A8-3FFF-A8F74BBD0C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2F4CC9-57D3-9B96-CE89-B84D572EEC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F69DCA-F292-59E8-FF22-40CEBE94E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92993A-2CCB-5AFE-EAB4-AE1A6E8DF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98E8C1-4870-603E-C625-49E9EE402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5090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E73B60-5A42-54A1-FF34-47B2F6BB0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31DBF6-4A11-237F-7B7A-CBA04BF9B2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324658-E8BA-D732-ED64-619D62814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1307A5-EC02-9292-EC14-318BAE6C1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7F11F4-C93A-D68E-E2C0-BD513A9798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861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2B2413-3B32-5867-D870-A483455550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DE349F-9477-06C4-E16F-D28EB99D9C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113AAF-4A42-0CA7-5DB1-52B3028700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CAE12F-7C76-A595-A2F4-B939860D0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5B9527-36F3-A04E-47C1-CFBAF6D54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66B0AF-944C-E290-607D-7F7161EEE9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901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375190-E04B-269A-AAFD-A1D4F97912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3FB0A2-A0D3-258F-33F9-6461DDB1E3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1816CF-69A9-5D46-591E-9FB906A2B2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275D1D0-BCA7-B23F-7647-17D12E9E8E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262808-FCB7-DB1F-A801-110C5A20DD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D34C67D-7EBC-9A4A-501C-E5BD4EF8B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0584DC7-3011-A873-31AD-5B3DDEDA8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D3411C-9C05-70B5-A7BD-D4BE65442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380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FDA051-4CF1-14A0-0B4A-BDDD5D3D0C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0BA187-F652-48F3-AE67-CEA23DFA49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060AB90-4B2C-811E-D739-C82CDC789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1780C6-30CE-70D3-1FD5-81178B9432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14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188EB20-67CB-705F-92AF-63E30AF2E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8B3210-32DA-7A3C-2B4E-741E9B38A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14D53D-B8AC-864D-0AC5-DA6DB80CF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37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DC930-8651-3EE3-B1D1-9A31D6755B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C3C9E8-4D12-D5A3-5432-8A77C7CBDD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CD5359-0B90-65B9-8146-52DFB9B2D0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2B117C-C88F-F6A3-473E-7021DC0EA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210967-B513-D89B-8310-FB3BD1437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30E4D6-D451-28DA-A863-8C64F5E36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376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16048A-8476-A54E-B7B0-8D482CA3C3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16DF06-2646-319D-EBD5-6350E5FDE4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C6AD1F-2AEE-E7A8-C6B1-F91A2CB546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BE4732-2961-95E9-3720-43C696976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F9BC44-E60E-560F-82C5-9021CB3BCA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90AA0F-F81D-362C-424B-5C40735E9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530C0C-128C-482D-4012-F4A07CAC64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CCCE36-DC34-CAD6-F35D-E938FD1C8E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A40070-4517-48D4-C10A-F6A3DEBE7D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B6BE3D-7520-4A23-98E0-FA923F971A66}" type="datetimeFigureOut">
              <a:rPr lang="en-US" smtClean="0"/>
              <a:t>3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296A27-D6E0-51B0-BD28-FAACD4E7BC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D9676E-973E-1AEE-3734-8901B2AC11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1ED24-E616-4F88-9050-1ED3921602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386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25">
            <a:extLst>
              <a:ext uri="{FF2B5EF4-FFF2-40B4-BE49-F238E27FC236}">
                <a16:creationId xmlns:a16="http://schemas.microsoft.com/office/drawing/2014/main" id="{AE9817D3-87BC-5A5D-55B8-ADFAC156E6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5451767"/>
              </p:ext>
            </p:extLst>
          </p:nvPr>
        </p:nvGraphicFramePr>
        <p:xfrm>
          <a:off x="151042" y="228598"/>
          <a:ext cx="5697306" cy="66294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721414">
                  <a:extLst>
                    <a:ext uri="{9D8B030D-6E8A-4147-A177-3AD203B41FA5}">
                      <a16:colId xmlns:a16="http://schemas.microsoft.com/office/drawing/2014/main" val="3698225441"/>
                    </a:ext>
                  </a:extLst>
                </a:gridCol>
                <a:gridCol w="1094762">
                  <a:extLst>
                    <a:ext uri="{9D8B030D-6E8A-4147-A177-3AD203B41FA5}">
                      <a16:colId xmlns:a16="http://schemas.microsoft.com/office/drawing/2014/main" val="256517041"/>
                    </a:ext>
                  </a:extLst>
                </a:gridCol>
                <a:gridCol w="804542">
                  <a:extLst>
                    <a:ext uri="{9D8B030D-6E8A-4147-A177-3AD203B41FA5}">
                      <a16:colId xmlns:a16="http://schemas.microsoft.com/office/drawing/2014/main" val="3244172147"/>
                    </a:ext>
                  </a:extLst>
                </a:gridCol>
                <a:gridCol w="1152452">
                  <a:extLst>
                    <a:ext uri="{9D8B030D-6E8A-4147-A177-3AD203B41FA5}">
                      <a16:colId xmlns:a16="http://schemas.microsoft.com/office/drawing/2014/main" val="354379288"/>
                    </a:ext>
                  </a:extLst>
                </a:gridCol>
                <a:gridCol w="924136">
                  <a:extLst>
                    <a:ext uri="{9D8B030D-6E8A-4147-A177-3AD203B41FA5}">
                      <a16:colId xmlns:a16="http://schemas.microsoft.com/office/drawing/2014/main" val="470700851"/>
                    </a:ext>
                  </a:extLst>
                </a:gridCol>
              </a:tblGrid>
              <a:tr h="153542"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 ho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ed 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fo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9701447"/>
                  </a:ext>
                </a:extLst>
              </a:tr>
              <a:tr h="153542">
                <a:tc gridSpan="5"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tibodies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7394481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l-G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ctin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333370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t (pan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6940706"/>
                  </a:ext>
                </a:extLst>
              </a:tr>
              <a:tr h="153542">
                <a:tc rowSpan="2">
                  <a:txBody>
                    <a:bodyPr/>
                    <a:lstStyle/>
                    <a:p>
                      <a:r>
                        <a:rPr lang="en-US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thrin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5459643"/>
                  </a:ext>
                </a:extLst>
              </a:tr>
              <a:tr h="153542">
                <a:tc v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4217052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ynamin (I &amp; II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193706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K1/2 (p44/42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166994"/>
                  </a:ext>
                </a:extLst>
              </a:tr>
              <a:tr h="153542">
                <a:tc rowSpan="2"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DAC6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0993081"/>
                  </a:ext>
                </a:extLst>
              </a:tr>
              <a:tr h="153542">
                <a:tc v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(IgG1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Fishe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1427866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ortin-</a:t>
                      </a:r>
                      <a:r>
                        <a:rPr lang="el-G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1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3432802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QGAP1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7364498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K1/2</a:t>
                      </a:r>
                      <a:endParaRPr lang="el-GR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088627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K1</a:t>
                      </a:r>
                      <a:endParaRPr lang="el-GR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5392807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C</a:t>
                      </a:r>
                      <a:r>
                        <a:rPr lang="el-G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1740447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3K-p85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6038971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3K (p110</a:t>
                      </a:r>
                      <a:r>
                        <a:rPr lang="el-G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&amp; p110</a:t>
                      </a:r>
                      <a:r>
                        <a:rPr lang="el-G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5428058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4K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6599451"/>
                  </a:ext>
                </a:extLst>
              </a:tr>
              <a:tr h="153542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C</a:t>
                      </a:r>
                      <a:r>
                        <a:rPr lang="el-G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γ1</a:t>
                      </a: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6772088"/>
                  </a:ext>
                </a:extLst>
              </a:tr>
              <a:tr h="153542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&amp;D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813536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EN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5325878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c1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9497411"/>
                  </a:ext>
                </a:extLst>
              </a:tr>
              <a:tr h="153542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4SF1 (8G4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(IgG1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giex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 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1452185"/>
                  </a:ext>
                </a:extLst>
              </a:tr>
              <a:tr h="153542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(IgG1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llipore Sigma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 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4770607"/>
                  </a:ext>
                </a:extLst>
              </a:tr>
              <a:tr h="153542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ulin (total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(IgG2a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4031754"/>
                  </a:ext>
                </a:extLst>
              </a:tr>
              <a:tr h="153542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1705022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l-G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ulin </a:t>
                      </a:r>
                      <a:r>
                        <a:rPr lang="en-US" sz="9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cetylated Lys 40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(IgG2b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3469812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GFR2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, WB, 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4371429"/>
                  </a:ext>
                </a:extLst>
              </a:tr>
              <a:tr h="153542">
                <a:tc>
                  <a:txBody>
                    <a:bodyPr/>
                    <a:lstStyle/>
                    <a:p>
                      <a:r>
                        <a:rPr lang="en-US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sphotyrosine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4G10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(IgG2b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llipore Sigma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506431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5A836D4-10CE-5343-48E0-69278244B5D7}"/>
              </a:ext>
            </a:extLst>
          </p:cNvPr>
          <p:cNvSpPr txBox="1"/>
          <p:nvPr/>
        </p:nvSpPr>
        <p:spPr>
          <a:xfrm>
            <a:off x="4104498" y="-49695"/>
            <a:ext cx="36649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able S1. Antibodies used in the current study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15C0746-492B-80FE-C2E3-D4D82D8F3C8A}"/>
              </a:ext>
            </a:extLst>
          </p:cNvPr>
          <p:cNvSpPr txBox="1"/>
          <p:nvPr/>
        </p:nvSpPr>
        <p:spPr>
          <a:xfrm>
            <a:off x="6168614" y="3167389"/>
            <a:ext cx="55514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b, antibodies. All rabbit and goat primary antibodies are polyclonal antibodies. Cell Signaling Technology (Danvers, MA), Santa Cruz (Dallas, TX), </a:t>
            </a:r>
            <a:r>
              <a:rPr lang="en-US" sz="1200" dirty="0" err="1"/>
              <a:t>ThermoFisher</a:t>
            </a:r>
            <a:r>
              <a:rPr lang="en-US" sz="1200" dirty="0"/>
              <a:t> (Waltham, MA), Millipore Sigma (Burlington, MA) and R&amp;D Systems (Minneapolis, MN). MW, molecular weight. </a:t>
            </a:r>
            <a:r>
              <a:rPr lang="el-GR" sz="1200" dirty="0"/>
              <a:t>α</a:t>
            </a:r>
            <a:r>
              <a:rPr lang="en-US" sz="1200" dirty="0"/>
              <a:t>Tubulin (acetylated Lys40). ERK1/2 (p44/42 MAPK)</a:t>
            </a:r>
          </a:p>
        </p:txBody>
      </p:sp>
      <p:graphicFrame>
        <p:nvGraphicFramePr>
          <p:cNvPr id="5" name="Table 125">
            <a:extLst>
              <a:ext uri="{FF2B5EF4-FFF2-40B4-BE49-F238E27FC236}">
                <a16:creationId xmlns:a16="http://schemas.microsoft.com/office/drawing/2014/main" id="{F8606F42-9606-C267-4728-6369A7B9052C}"/>
              </a:ext>
            </a:extLst>
          </p:cNvPr>
          <p:cNvGraphicFramePr>
            <a:graphicFrameLocks noGrp="1"/>
          </p:cNvGraphicFramePr>
          <p:nvPr/>
        </p:nvGraphicFramePr>
        <p:xfrm>
          <a:off x="6096000" y="228600"/>
          <a:ext cx="5696712" cy="27432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721235">
                  <a:extLst>
                    <a:ext uri="{9D8B030D-6E8A-4147-A177-3AD203B41FA5}">
                      <a16:colId xmlns:a16="http://schemas.microsoft.com/office/drawing/2014/main" val="3698225441"/>
                    </a:ext>
                  </a:extLst>
                </a:gridCol>
                <a:gridCol w="1094647">
                  <a:extLst>
                    <a:ext uri="{9D8B030D-6E8A-4147-A177-3AD203B41FA5}">
                      <a16:colId xmlns:a16="http://schemas.microsoft.com/office/drawing/2014/main" val="256517041"/>
                    </a:ext>
                  </a:extLst>
                </a:gridCol>
                <a:gridCol w="804458">
                  <a:extLst>
                    <a:ext uri="{9D8B030D-6E8A-4147-A177-3AD203B41FA5}">
                      <a16:colId xmlns:a16="http://schemas.microsoft.com/office/drawing/2014/main" val="3244172147"/>
                    </a:ext>
                  </a:extLst>
                </a:gridCol>
                <a:gridCol w="1152332">
                  <a:extLst>
                    <a:ext uri="{9D8B030D-6E8A-4147-A177-3AD203B41FA5}">
                      <a16:colId xmlns:a16="http://schemas.microsoft.com/office/drawing/2014/main" val="354379288"/>
                    </a:ext>
                  </a:extLst>
                </a:gridCol>
                <a:gridCol w="924040">
                  <a:extLst>
                    <a:ext uri="{9D8B030D-6E8A-4147-A177-3AD203B41FA5}">
                      <a16:colId xmlns:a16="http://schemas.microsoft.com/office/drawing/2014/main" val="470700851"/>
                    </a:ext>
                  </a:extLst>
                </a:gridCol>
              </a:tblGrid>
              <a:tr h="130238"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 ho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ed 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od fo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9701447"/>
                  </a:ext>
                </a:extLst>
              </a:tr>
              <a:tr h="130238">
                <a:tc gridSpan="5"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9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tibodies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6632454"/>
                  </a:ext>
                </a:extLst>
              </a:tr>
              <a:tr h="130238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rabbit IgG-HRP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6381197"/>
                  </a:ext>
                </a:extLst>
              </a:tr>
              <a:tr h="13023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mouse IgG-HRP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rse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6836086"/>
                  </a:ext>
                </a:extLst>
              </a:tr>
              <a:tr h="13023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goat IgG-HRP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key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Fishe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56834023"/>
                  </a:ext>
                </a:extLst>
              </a:tr>
              <a:tr h="13316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mouse IgG-Alexa488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key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Fishe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6716610"/>
                  </a:ext>
                </a:extLst>
              </a:tr>
              <a:tr h="13023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rabbit IgG-Alexa488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key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Fishe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3345509"/>
                  </a:ext>
                </a:extLst>
              </a:tr>
              <a:tr h="13316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human IgG-Alexa488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Fishe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4612303"/>
                  </a:ext>
                </a:extLst>
              </a:tr>
              <a:tr h="13316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human IgG-Alexa594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Fishe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38703919"/>
                  </a:ext>
                </a:extLst>
              </a:tr>
              <a:tr h="130238">
                <a:tc gridSpan="5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otype-matched control antibodies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 sz="9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7946768"/>
                  </a:ext>
                </a:extLst>
              </a:tr>
              <a:tr h="13023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G1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Fishe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1975823"/>
                  </a:ext>
                </a:extLst>
              </a:tr>
              <a:tr h="13023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gG1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Fishe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18695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15596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5</Words>
  <Application>Microsoft Office PowerPoint</Application>
  <PresentationFormat>Widescreen</PresentationFormat>
  <Paragraphs>18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ou-Ching Jaminet</dc:creator>
  <cp:lastModifiedBy>Shou-Ching Jaminet</cp:lastModifiedBy>
  <cp:revision>1</cp:revision>
  <dcterms:created xsi:type="dcterms:W3CDTF">2024-03-06T13:56:25Z</dcterms:created>
  <dcterms:modified xsi:type="dcterms:W3CDTF">2024-03-06T13:57:03Z</dcterms:modified>
</cp:coreProperties>
</file>